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8" r:id="rId4"/>
    <p:sldId id="259" r:id="rId5"/>
    <p:sldId id="261" r:id="rId6"/>
    <p:sldId id="25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58"/>
  </p:normalViewPr>
  <p:slideViewPr>
    <p:cSldViewPr snapToGrid="0">
      <p:cViewPr varScale="1">
        <p:scale>
          <a:sx n="92" d="100"/>
          <a:sy n="92" d="100"/>
        </p:scale>
        <p:origin x="784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CD2027-C559-485C-82F0-1412A07EA3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27E368F-752E-4445-AA53-A2C3B2A354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7DB530-AD4D-4BC7-80F0-5F2860CECC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0A6A5-249B-44B7-9B1E-80FBD759D5A5}" type="datetimeFigureOut">
              <a:rPr lang="en-US" smtClean="0"/>
              <a:t>12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CAE219-445D-46E8-820F-3E36FDC2D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1CD918-E782-4CDB-AFBA-4CD7FB34E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57BF3-679D-4ED2-8E37-5D5B77414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5844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D61A55-1071-466B-883A-022B9E260D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927080-DB23-4D04-83C7-39FC76D4BD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6E293A-771B-4D7A-842D-D91151F88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0A6A5-249B-44B7-9B1E-80FBD759D5A5}" type="datetimeFigureOut">
              <a:rPr lang="en-US" smtClean="0"/>
              <a:t>12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07C620-39F1-4840-9576-2477E1295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826665-5FD3-41F6-A8EC-BC3E7B94A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57BF3-679D-4ED2-8E37-5D5B77414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485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D6691A-573F-4DB2-AD2C-633DFD1548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B713FDE-3976-47B1-9B54-0F2891110F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AE42A6-D3A6-40AE-B277-FEA5BB9F9C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0A6A5-249B-44B7-9B1E-80FBD759D5A5}" type="datetimeFigureOut">
              <a:rPr lang="en-US" smtClean="0"/>
              <a:t>12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346A06-44DE-49DA-B17F-CF3702406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5377ED-49BC-4B1D-9E84-7500E9849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57BF3-679D-4ED2-8E37-5D5B77414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5799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D1C861-8F85-4147-B166-515C470B01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67D887-F163-4398-BB49-C6D95214FD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E85FE2-FCF3-4FFD-9155-E578F3348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0A6A5-249B-44B7-9B1E-80FBD759D5A5}" type="datetimeFigureOut">
              <a:rPr lang="en-US" smtClean="0"/>
              <a:t>12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E78379-1BCA-49F7-905B-DA02470742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95E23B-5D71-4043-AE54-31A65EFF2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57BF3-679D-4ED2-8E37-5D5B77414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012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5A247E-8459-4E63-B243-FF1194C8B8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23C11F-9012-42F9-93B0-BB0996BE3A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95DAA5-3EBA-49BB-988D-D7F703114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0A6A5-249B-44B7-9B1E-80FBD759D5A5}" type="datetimeFigureOut">
              <a:rPr lang="en-US" smtClean="0"/>
              <a:t>12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F8E3A6-4D82-485F-A230-96F57908CE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AA1605-35BE-4CE9-AA59-96C0E739E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57BF3-679D-4ED2-8E37-5D5B77414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13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9FF1A-76FD-46E9-9A94-6DE5CEF06E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8D552C-3A72-4990-BA17-F67B806F6E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A9A61C-57E9-45F0-99AF-5029F70708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FE89D1-AD67-49E5-A5CA-EFEDAE676E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0A6A5-249B-44B7-9B1E-80FBD759D5A5}" type="datetimeFigureOut">
              <a:rPr lang="en-US" smtClean="0"/>
              <a:t>12/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10963C-46A4-4DF2-ADD2-C7EF4B8B0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023474-A544-4313-B788-116E8D0B9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57BF3-679D-4ED2-8E37-5D5B77414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117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7652A1-6CF7-48D0-B199-96229BC848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282510-97BE-4FF9-B4AF-636735A57E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4A7C89-AE9E-4E8D-8A01-BD8EF48DD8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6D8D088-EF99-47EB-A5E6-A2398FF5BE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6A107E4-17DA-438C-B3D6-737899325A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CC9847-CDA3-4843-B666-B173332AF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0A6A5-249B-44B7-9B1E-80FBD759D5A5}" type="datetimeFigureOut">
              <a:rPr lang="en-US" smtClean="0"/>
              <a:t>12/9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3A5AB35-C60D-4EFF-B50A-251FD502A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719795B-6513-4440-992F-D4A488414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57BF3-679D-4ED2-8E37-5D5B77414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444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DCBD04-3EE5-4F50-98BC-3FFA5C5D1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BD4636-6B25-46D6-91A5-5C7762048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0A6A5-249B-44B7-9B1E-80FBD759D5A5}" type="datetimeFigureOut">
              <a:rPr lang="en-US" smtClean="0"/>
              <a:t>12/9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434101A-4815-4FF6-93AD-7E188B4546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C5B4DA-9166-431B-BF7E-75702B2DBE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57BF3-679D-4ED2-8E37-5D5B77414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261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45E470-BE8D-411B-92C8-72AC8FA31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0A6A5-249B-44B7-9B1E-80FBD759D5A5}" type="datetimeFigureOut">
              <a:rPr lang="en-US" smtClean="0"/>
              <a:t>12/9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1620152-EBBD-40B5-AF88-80E043FE35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C60441-FA59-4E55-A2EC-09947538E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57BF3-679D-4ED2-8E37-5D5B77414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390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081BC4-9887-4BBC-8177-64F024C625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44ADB6-4ABC-42DB-9929-C3396555AE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3AE038-2F80-4FBE-938D-B5208323C5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7F8452-94CF-4205-AEA9-A6A02F03C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0A6A5-249B-44B7-9B1E-80FBD759D5A5}" type="datetimeFigureOut">
              <a:rPr lang="en-US" smtClean="0"/>
              <a:t>12/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8F0C54-69D8-4739-81DD-1586E8385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EAD6E9-128D-4229-9CE0-693269FEF4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57BF3-679D-4ED2-8E37-5D5B77414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636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C3887F-E322-427D-8C80-8191080932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17B609C-2B92-42C7-9A76-4D8838A10A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49123A-D721-4E30-B7DA-EB69D6774C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0C2391-3E9C-4DB1-A194-00E51A268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0A6A5-249B-44B7-9B1E-80FBD759D5A5}" type="datetimeFigureOut">
              <a:rPr lang="en-US" smtClean="0"/>
              <a:t>12/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95DA1E-3AD0-4EE5-BAF2-8B89886C7A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EFC414-F785-4690-BEB8-861D583BF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57BF3-679D-4ED2-8E37-5D5B77414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790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2199C0D-96D4-4299-A876-25BC151B9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05C407-8775-4117-AE99-181444EDBA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F7E825-577B-45AC-AE42-2C66AA5524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0A6A5-249B-44B7-9B1E-80FBD759D5A5}" type="datetimeFigureOut">
              <a:rPr lang="en-US" smtClean="0"/>
              <a:t>12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29341F-72F3-4A69-A59E-BBDD916437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B7DC79-5EDD-44A6-A5C8-B666072E82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57BF3-679D-4ED2-8E37-5D5B77414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719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30752" y="162838"/>
            <a:ext cx="4323837" cy="6344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73CE7BF-CDD4-4C2A-B008-5E3BA0F5476C}"/>
              </a:ext>
            </a:extLst>
          </p:cNvPr>
          <p:cNvSpPr txBox="1"/>
          <p:nvPr/>
        </p:nvSpPr>
        <p:spPr>
          <a:xfrm>
            <a:off x="0" y="6458994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1: Explanation of the Bayesian rank-based clustering method. A) determining the </a:t>
            </a:r>
            <a:r>
              <a:rPr lang="nb-NO" sz="1200" dirty="0"/>
              <a:t>rank matrix from the expression matrix. B) Bayes Mallows for determining cluster assignment </a:t>
            </a:r>
            <a:r>
              <a:rPr lang="en-US" sz="1200" dirty="0"/>
              <a:t> </a:t>
            </a:r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43" y="162839"/>
            <a:ext cx="7615873" cy="4495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C72F8A9-112C-41BB-8B3A-DE6AC75E4B44}"/>
              </a:ext>
            </a:extLst>
          </p:cNvPr>
          <p:cNvSpPr txBox="1"/>
          <p:nvPr/>
        </p:nvSpPr>
        <p:spPr>
          <a:xfrm>
            <a:off x="17086" y="0"/>
            <a:ext cx="571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C72F8A9-112C-41BB-8B3A-DE6AC75E4B44}"/>
              </a:ext>
            </a:extLst>
          </p:cNvPr>
          <p:cNvSpPr txBox="1"/>
          <p:nvPr/>
        </p:nvSpPr>
        <p:spPr>
          <a:xfrm>
            <a:off x="7634568" y="0"/>
            <a:ext cx="571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31854167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73CE7BF-CDD4-4C2A-B008-5E3BA0F5476C}"/>
              </a:ext>
            </a:extLst>
          </p:cNvPr>
          <p:cNvSpPr txBox="1"/>
          <p:nvPr/>
        </p:nvSpPr>
        <p:spPr>
          <a:xfrm>
            <a:off x="0" y="6007778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2: Bayes Mallows clustering method on a random selection of 1247 genes. A) Elbow plot; we chose C=17. B) Cluster assignments of tumor samples obtained via Bayes Mallows. The cluster numbers are matched to represent the original </a:t>
            </a:r>
            <a:r>
              <a:rPr lang="en-US" sz="1200" dirty="0" err="1"/>
              <a:t>RankClusters</a:t>
            </a:r>
            <a:r>
              <a:rPr lang="en-US" sz="1200" dirty="0"/>
              <a:t> in Figure 3. C) Table showing concordance between clustering using the “Ciriello genes” and random genes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BBBF783-F068-4078-9380-5170960325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732" y="338516"/>
            <a:ext cx="3284606" cy="176117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C72F8A9-112C-41BB-8B3A-DE6AC75E4B44}"/>
              </a:ext>
            </a:extLst>
          </p:cNvPr>
          <p:cNvSpPr txBox="1"/>
          <p:nvPr/>
        </p:nvSpPr>
        <p:spPr>
          <a:xfrm>
            <a:off x="17086" y="0"/>
            <a:ext cx="571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85C6594-B7EA-49FA-9732-E482D9AEEC18}"/>
              </a:ext>
            </a:extLst>
          </p:cNvPr>
          <p:cNvSpPr txBox="1"/>
          <p:nvPr/>
        </p:nvSpPr>
        <p:spPr>
          <a:xfrm>
            <a:off x="3911904" y="0"/>
            <a:ext cx="571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83E0ED0-64EF-435B-BC38-2345C59C57E8}"/>
              </a:ext>
            </a:extLst>
          </p:cNvPr>
          <p:cNvSpPr txBox="1"/>
          <p:nvPr/>
        </p:nvSpPr>
        <p:spPr>
          <a:xfrm>
            <a:off x="17086" y="2509203"/>
            <a:ext cx="571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)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76626F09-8F74-45E1-AC47-D2915AF0450F}"/>
              </a:ext>
            </a:extLst>
          </p:cNvPr>
          <p:cNvGrpSpPr/>
          <p:nvPr/>
        </p:nvGrpSpPr>
        <p:grpSpPr>
          <a:xfrm>
            <a:off x="4112223" y="203891"/>
            <a:ext cx="7917086" cy="3896769"/>
            <a:chOff x="4112223" y="203891"/>
            <a:chExt cx="7917086" cy="3896769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36B95AB1-1EBE-4DB7-A8CE-52300B6EBE1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95012" y="203891"/>
              <a:ext cx="7734297" cy="3896769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D6DD045-444A-4EFB-9302-AB6A782DEB7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12223" y="722816"/>
              <a:ext cx="685800" cy="1771650"/>
            </a:xfrm>
            <a:prstGeom prst="rect">
              <a:avLst/>
            </a:prstGeom>
          </p:spPr>
        </p:pic>
      </p:grpSp>
      <p:pic>
        <p:nvPicPr>
          <p:cNvPr id="14" name="Picture 13">
            <a:extLst>
              <a:ext uri="{FF2B5EF4-FFF2-40B4-BE49-F238E27FC236}">
                <a16:creationId xmlns:a16="http://schemas.microsoft.com/office/drawing/2014/main" id="{DB6402B8-B600-478E-B7B5-61621A85C3C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9419" y="3114248"/>
            <a:ext cx="4002804" cy="25442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33536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D14152E4-C9D2-4C32-870A-39BA5DAE0A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48168" y="130225"/>
            <a:ext cx="4259988" cy="245272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73CE7BF-CDD4-4C2A-B008-5E3BA0F5476C}"/>
              </a:ext>
            </a:extLst>
          </p:cNvPr>
          <p:cNvSpPr txBox="1"/>
          <p:nvPr/>
        </p:nvSpPr>
        <p:spPr>
          <a:xfrm>
            <a:off x="0" y="5679634"/>
            <a:ext cx="737942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3: Hierarchical clustering and comparison to RankClusters and random gene selection. A) Hierarchical clustering of the 2617 pan-cancer samples from 12 cancer types using the 1247 “Ciriello genes”. C is chosen to be 16. B) Table showing concordance between </a:t>
            </a:r>
            <a:r>
              <a:rPr lang="en-US" sz="1200" dirty="0" err="1"/>
              <a:t>RankClusters</a:t>
            </a:r>
            <a:r>
              <a:rPr lang="en-US" sz="1200" dirty="0"/>
              <a:t> and hierarchical clustering using the “Ciriello genes”. The hierarchical clusters were named to best correspond to the </a:t>
            </a:r>
            <a:r>
              <a:rPr lang="en-US" sz="1200" dirty="0" err="1"/>
              <a:t>RankClusters</a:t>
            </a:r>
            <a:r>
              <a:rPr lang="en-US" sz="1200" dirty="0"/>
              <a:t>. C) Hierarchical clustering of the 2617 pan-cancer samples from 12 cancer types using 1247 random genes (the same as in Supplementary Figure 1). The clustering was performed using Euclidean distance and Ward linkage (ward.D2)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E423111-7B15-4183-8551-525D76C8B76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8491" y="1"/>
            <a:ext cx="5627802" cy="5627802"/>
          </a:xfrm>
          <a:prstGeom prst="rect">
            <a:avLst/>
          </a:prstGeom>
        </p:spPr>
      </p:pic>
      <p:pic>
        <p:nvPicPr>
          <p:cNvPr id="6" name="Picture 5" descr="Chart&#10;&#10;Description automatically generated with low confidence">
            <a:extLst>
              <a:ext uri="{FF2B5EF4-FFF2-40B4-BE49-F238E27FC236}">
                <a16:creationId xmlns:a16="http://schemas.microsoft.com/office/drawing/2014/main" id="{11F356AC-13FC-4532-B95A-F21BB1C455F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9421" y="2658976"/>
            <a:ext cx="4068799" cy="406879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065965A-9381-44E3-BD21-E0FF65F6D487}"/>
              </a:ext>
            </a:extLst>
          </p:cNvPr>
          <p:cNvSpPr txBox="1"/>
          <p:nvPr/>
        </p:nvSpPr>
        <p:spPr>
          <a:xfrm>
            <a:off x="73646" y="87784"/>
            <a:ext cx="571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1B701E-CF2B-449B-ABF8-A22E942E9EC6}"/>
              </a:ext>
            </a:extLst>
          </p:cNvPr>
          <p:cNvSpPr txBox="1"/>
          <p:nvPr/>
        </p:nvSpPr>
        <p:spPr>
          <a:xfrm>
            <a:off x="6807921" y="2634776"/>
            <a:ext cx="571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AAD2A96-B0E9-48BD-A72A-8958807298F3}"/>
              </a:ext>
            </a:extLst>
          </p:cNvPr>
          <p:cNvSpPr txBox="1"/>
          <p:nvPr/>
        </p:nvSpPr>
        <p:spPr>
          <a:xfrm>
            <a:off x="5847075" y="87784"/>
            <a:ext cx="571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948670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43B4B17-558D-4BC8-85ED-828F0F89A12C}"/>
              </a:ext>
            </a:extLst>
          </p:cNvPr>
          <p:cNvSpPr txBox="1"/>
          <p:nvPr/>
        </p:nvSpPr>
        <p:spPr>
          <a:xfrm>
            <a:off x="0" y="6007778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4: Density of the counts of how many times a top-ranked gene (for a given RankCluster) was top-ranked also for other </a:t>
            </a:r>
            <a:r>
              <a:rPr lang="en-US" sz="1200" dirty="0" err="1"/>
              <a:t>RankClusters</a:t>
            </a:r>
            <a:r>
              <a:rPr lang="en-US" sz="1200" dirty="0"/>
              <a:t> for genes with at least 1% probability of being ranked top-100 in each cluster. All cluster-specific densities were tested via a Kolmogorov-Smirnoff goodness-of-fit test to show that the co-occurrence counts are stochastically larger/smaller than expected if due to random variation only. Clusters showing significant stochastically larger (smaller) counts are shown in red (blue) in the figure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2845788-5975-46D0-8C59-598A911DF6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6927" y="313969"/>
            <a:ext cx="7338266" cy="48896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25840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73CE7BF-CDD4-4C2A-B008-5E3BA0F5476C}"/>
              </a:ext>
            </a:extLst>
          </p:cNvPr>
          <p:cNvSpPr txBox="1"/>
          <p:nvPr/>
        </p:nvSpPr>
        <p:spPr>
          <a:xfrm>
            <a:off x="0" y="6007778"/>
            <a:ext cx="121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5: Kaplan-Meier plot of progression-free survival for patients in the three pan-squamous RankClusters. P-value is calculated using log-rank test. 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8545" y="262966"/>
            <a:ext cx="5740680" cy="56163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4192103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73CE7BF-CDD4-4C2A-B008-5E3BA0F5476C}"/>
              </a:ext>
            </a:extLst>
          </p:cNvPr>
          <p:cNvSpPr txBox="1"/>
          <p:nvPr/>
        </p:nvSpPr>
        <p:spPr>
          <a:xfrm>
            <a:off x="0" y="6007778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6: Average allele-specific copy number of tumors (ASCAT)-estimated tumor purities for the 16 RankClusters. Boxplots showing the estimated tumor purity for each sample in each RankCluster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3445C1B2-05A3-4056-9A3B-8D4C895E7A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9436" y="448246"/>
            <a:ext cx="7965648" cy="47793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51443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7</TotalTime>
  <Words>378</Words>
  <Application>Microsoft Macintosh PowerPoint</Application>
  <PresentationFormat>Widescreen</PresentationFormat>
  <Paragraphs>1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Fleischer</dc:creator>
  <cp:lastModifiedBy>Manuela Zucknick</cp:lastModifiedBy>
  <cp:revision>13</cp:revision>
  <dcterms:created xsi:type="dcterms:W3CDTF">2021-12-10T09:00:01Z</dcterms:created>
  <dcterms:modified xsi:type="dcterms:W3CDTF">2022-12-09T10:55:38Z</dcterms:modified>
</cp:coreProperties>
</file>